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54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组合 17">
            <a:extLst>
              <a:ext uri="{FF2B5EF4-FFF2-40B4-BE49-F238E27FC236}">
                <a16:creationId xmlns:a16="http://schemas.microsoft.com/office/drawing/2014/main" id="{5DAEB89B-E9F7-439B-9FB1-080F5CDC45D3}"/>
              </a:ext>
            </a:extLst>
          </p:cNvPr>
          <p:cNvGrpSpPr/>
          <p:nvPr/>
        </p:nvGrpSpPr>
        <p:grpSpPr>
          <a:xfrm>
            <a:off x="639596" y="807185"/>
            <a:ext cx="5277110" cy="5633109"/>
            <a:chOff x="639596" y="807185"/>
            <a:chExt cx="5277110" cy="5633109"/>
          </a:xfrm>
        </p:grpSpPr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id="{CB31CC72-5357-4BCA-AD8A-22D565F0D4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372" b="8894"/>
            <a:stretch/>
          </p:blipFill>
          <p:spPr>
            <a:xfrm>
              <a:off x="1075765" y="1021976"/>
              <a:ext cx="4831976" cy="2357718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D5221C82-A10B-4DAA-9F29-2B025BD6DE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232" b="9173"/>
            <a:stretch/>
          </p:blipFill>
          <p:spPr>
            <a:xfrm>
              <a:off x="1093694" y="3801036"/>
              <a:ext cx="4823012" cy="2456330"/>
            </a:xfrm>
            <a:prstGeom prst="rect">
              <a:avLst/>
            </a:prstGeom>
          </p:spPr>
        </p:pic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BE99CD3E-8C4A-44EA-91AB-9CF4ACEE851B}"/>
                </a:ext>
              </a:extLst>
            </p:cNvPr>
            <p:cNvGrpSpPr/>
            <p:nvPr/>
          </p:nvGrpSpPr>
          <p:grpSpPr>
            <a:xfrm>
              <a:off x="639596" y="807185"/>
              <a:ext cx="5071464" cy="5633109"/>
              <a:chOff x="527108" y="1122750"/>
              <a:chExt cx="5071464" cy="5633109"/>
            </a:xfrm>
          </p:grpSpPr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A440778F-BD94-40AA-BD9D-862A6B3A0339}"/>
                  </a:ext>
                </a:extLst>
              </p:cNvPr>
              <p:cNvSpPr txBox="1"/>
              <p:nvPr/>
            </p:nvSpPr>
            <p:spPr>
              <a:xfrm>
                <a:off x="2239958" y="1145833"/>
                <a:ext cx="2824093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in steroid biosynthesis pathway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2E363D99-86C7-45B3-B2E6-2E2B85B4AC4D}"/>
                  </a:ext>
                </a:extLst>
              </p:cNvPr>
              <p:cNvSpPr txBox="1"/>
              <p:nvPr/>
            </p:nvSpPr>
            <p:spPr>
              <a:xfrm>
                <a:off x="1709807" y="3676510"/>
                <a:ext cx="388439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   R1min             R30min             R45min               R6h    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A2D05A30-3F45-4877-B533-435C3A6F6888}"/>
                  </a:ext>
                </a:extLst>
              </p:cNvPr>
              <p:cNvSpPr txBox="1"/>
              <p:nvPr/>
            </p:nvSpPr>
            <p:spPr>
              <a:xfrm>
                <a:off x="527108" y="1122750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83C9F605-84B0-4F44-868A-027D810BADFF}"/>
                  </a:ext>
                </a:extLst>
              </p:cNvPr>
              <p:cNvSpPr txBox="1"/>
              <p:nvPr/>
            </p:nvSpPr>
            <p:spPr>
              <a:xfrm>
                <a:off x="2013543" y="3944303"/>
                <a:ext cx="3276922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nigenes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annotated in </a:t>
                </a:r>
                <a:r>
                  <a:rPr lang="en-US" altLang="zh-CN" sz="8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rassinosteroid</a:t>
                </a:r>
                <a:r>
                  <a:rPr lang="en-US" altLang="zh-CN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biosynthesis pathway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3488E4AC-85C6-4FEE-873E-AA8BEBE07945}"/>
                  </a:ext>
                </a:extLst>
              </p:cNvPr>
              <p:cNvSpPr txBox="1"/>
              <p:nvPr/>
            </p:nvSpPr>
            <p:spPr>
              <a:xfrm>
                <a:off x="1656467" y="6540415"/>
                <a:ext cx="394210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     R1min             R30min             R45min               R6h    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4B50E100-22E5-46E3-B2F2-BF13CFE5B1D8}"/>
                  </a:ext>
                </a:extLst>
              </p:cNvPr>
              <p:cNvSpPr txBox="1"/>
              <p:nvPr/>
            </p:nvSpPr>
            <p:spPr>
              <a:xfrm>
                <a:off x="527108" y="3921220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6" name="文本框 15">
            <a:extLst>
              <a:ext uri="{FF2B5EF4-FFF2-40B4-BE49-F238E27FC236}">
                <a16:creationId xmlns:a16="http://schemas.microsoft.com/office/drawing/2014/main" id="{FAC943D1-8B9D-46A9-B5E7-073B68329216}"/>
              </a:ext>
            </a:extLst>
          </p:cNvPr>
          <p:cNvSpPr txBox="1"/>
          <p:nvPr/>
        </p:nvSpPr>
        <p:spPr>
          <a:xfrm>
            <a:off x="335492" y="6482013"/>
            <a:ext cx="62983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8.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proteins involved in steroid and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assinosteroid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iosynthesis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eroid biosynthesis pathway.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rassinosteroid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biosynthesis pathway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9018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2</TotalTime>
  <Words>63</Words>
  <Application>Microsoft Office PowerPoint</Application>
  <PresentationFormat>A4 纸张(210x297 毫米)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67</cp:revision>
  <dcterms:created xsi:type="dcterms:W3CDTF">2021-01-19T12:49:28Z</dcterms:created>
  <dcterms:modified xsi:type="dcterms:W3CDTF">2023-01-10T11:15:59Z</dcterms:modified>
</cp:coreProperties>
</file>